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CAB68-A3C5-4B11-B180-703C4A07F6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0F059-80E3-4648-B9B1-127F2F705D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FCBFF-870D-4819-9B1A-FCE6029014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ACC917-EC88-40FA-98DC-B8891A64B2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01D15-0335-4774-83F8-2592046074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0DAD9-AEB6-48F2-8D0B-DB523637A7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38D7A-7B05-4903-8EEB-AC29A458AB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27476-0092-4450-A0D4-4DAFF8DD81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5224D-F84F-4749-A9B0-E5204A815E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81976D-E916-4CBA-B4DE-8DDD285806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BF42A-A017-4986-9ADC-0FFD0563F6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E3F567-12E9-407F-AF78-2C2A0D268E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77297D-115B-441F-8F5C-D6004F46124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package" Target="../embeddings/oleObject1.xlsx"/><Relationship Id="rId4" Type="http://schemas.openxmlformats.org/officeDocument/2006/relationships/image" Target="../media/image3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9680" y="428760"/>
            <a:ext cx="235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upporting Information 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0920" y="4129920"/>
            <a:ext cx="8351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orting Information 1: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In AsPC-1 cells Bcl-2 expression was not detectable using western blot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. We determined the optimal time point for harvesting by activation of caspase 3 and 7. The groups displayed a similar kinetic response to transfection. The dynamic measurement was conducted every 12 hours after transfection. All Caspase assays were done in duplicate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95280" y="836640"/>
            <a:ext cx="2997000" cy="3097080"/>
            <a:chOff x="395280" y="836640"/>
            <a:chExt cx="2997000" cy="3097080"/>
          </a:xfrm>
        </p:grpSpPr>
        <p:grpSp>
          <p:nvGrpSpPr>
            <p:cNvPr id="44" name=""/>
            <p:cNvGrpSpPr/>
            <p:nvPr/>
          </p:nvGrpSpPr>
          <p:grpSpPr>
            <a:xfrm>
              <a:off x="395280" y="1200240"/>
              <a:ext cx="2997000" cy="2733480"/>
              <a:chOff x="395280" y="1200240"/>
              <a:chExt cx="2997000" cy="2733480"/>
            </a:xfrm>
          </p:grpSpPr>
          <p:sp>
            <p:nvSpPr>
              <p:cNvPr id="45" name=""/>
              <p:cNvSpPr/>
              <p:nvPr/>
            </p:nvSpPr>
            <p:spPr>
              <a:xfrm>
                <a:off x="395280" y="1200240"/>
                <a:ext cx="2948040" cy="2733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6" name=""/>
              <p:cNvGrpSpPr/>
              <p:nvPr/>
            </p:nvGrpSpPr>
            <p:grpSpPr>
              <a:xfrm>
                <a:off x="2479320" y="2458800"/>
                <a:ext cx="753120" cy="641520"/>
                <a:chOff x="2479320" y="2458800"/>
                <a:chExt cx="753120" cy="641520"/>
              </a:xfrm>
            </p:grpSpPr>
            <p:sp>
              <p:nvSpPr>
                <p:cNvPr id="47" name=""/>
                <p:cNvSpPr/>
                <p:nvPr/>
              </p:nvSpPr>
              <p:spPr>
                <a:xfrm>
                  <a:off x="2678400" y="2458800"/>
                  <a:ext cx="554040" cy="641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Bcl-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 flipH="1">
                  <a:off x="2479320" y="2773800"/>
                  <a:ext cx="294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lg" type="triangle" w="sm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49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160640" y="2522160"/>
                <a:ext cx="1243080" cy="382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"/>
              <p:cNvSpPr/>
              <p:nvPr/>
            </p:nvSpPr>
            <p:spPr>
              <a:xfrm>
                <a:off x="1149480" y="2352600"/>
                <a:ext cx="1251000" cy="6678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681120" y="25318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014480" y="2722320"/>
                <a:ext cx="135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3" name=""/>
              <p:cNvGrpSpPr/>
              <p:nvPr/>
            </p:nvGrpSpPr>
            <p:grpSpPr>
              <a:xfrm>
                <a:off x="1140120" y="3003480"/>
                <a:ext cx="2252160" cy="641520"/>
                <a:chOff x="1140120" y="3003480"/>
                <a:chExt cx="2252160" cy="641520"/>
              </a:xfrm>
            </p:grpSpPr>
            <p:grpSp>
              <p:nvGrpSpPr>
                <p:cNvPr id="54" name=""/>
                <p:cNvGrpSpPr/>
                <p:nvPr/>
              </p:nvGrpSpPr>
              <p:grpSpPr>
                <a:xfrm>
                  <a:off x="1140120" y="3099960"/>
                  <a:ext cx="1280520" cy="516600"/>
                  <a:chOff x="1140120" y="3099960"/>
                  <a:chExt cx="1280520" cy="516600"/>
                </a:xfrm>
              </p:grpSpPr>
              <p:pic>
                <p:nvPicPr>
                  <p:cNvPr id="5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55240" y="3132000"/>
                    <a:ext cx="1265400" cy="430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6" name=""/>
                  <p:cNvSpPr/>
                  <p:nvPr/>
                </p:nvSpPr>
                <p:spPr>
                  <a:xfrm>
                    <a:off x="1140120" y="3099960"/>
                    <a:ext cx="1261080" cy="51660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7" name=""/>
                <p:cNvGrpSpPr/>
                <p:nvPr/>
              </p:nvGrpSpPr>
              <p:grpSpPr>
                <a:xfrm>
                  <a:off x="2461680" y="3003480"/>
                  <a:ext cx="930600" cy="641520"/>
                  <a:chOff x="2461680" y="3003480"/>
                  <a:chExt cx="930600" cy="641520"/>
                </a:xfrm>
              </p:grpSpPr>
              <p:sp>
                <p:nvSpPr>
                  <p:cNvPr id="58" name=""/>
                  <p:cNvSpPr/>
                  <p:nvPr/>
                </p:nvSpPr>
                <p:spPr>
                  <a:xfrm>
                    <a:off x="2661480" y="3003480"/>
                    <a:ext cx="730800" cy="641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APDH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"/>
                  <p:cNvSpPr/>
                  <p:nvPr/>
                </p:nvSpPr>
                <p:spPr>
                  <a:xfrm flipH="1">
                    <a:off x="2461680" y="3319920"/>
                    <a:ext cx="2941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lg" type="triangle" w="sm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60" name=""/>
              <p:cNvSpPr/>
              <p:nvPr/>
            </p:nvSpPr>
            <p:spPr>
              <a:xfrm>
                <a:off x="534960" y="1998360"/>
                <a:ext cx="592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D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1" name=""/>
              <p:cNvGrpSpPr/>
              <p:nvPr/>
            </p:nvGrpSpPr>
            <p:grpSpPr>
              <a:xfrm>
                <a:off x="1199880" y="1430640"/>
                <a:ext cx="1131120" cy="911880"/>
                <a:chOff x="1199880" y="1430640"/>
                <a:chExt cx="1131120" cy="911880"/>
              </a:xfrm>
            </p:grpSpPr>
            <p:sp>
              <p:nvSpPr>
                <p:cNvPr id="62" name=""/>
                <p:cNvSpPr/>
                <p:nvPr/>
              </p:nvSpPr>
              <p:spPr>
                <a:xfrm rot="10800000">
                  <a:off x="1603080" y="1705680"/>
                  <a:ext cx="727920" cy="636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AsPC-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AsPC-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 rot="10800000">
                  <a:off x="1199880" y="1430640"/>
                  <a:ext cx="362880" cy="909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Mia PaCa-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4" name=""/>
            <p:cNvSpPr/>
            <p:nvPr/>
          </p:nvSpPr>
          <p:spPr>
            <a:xfrm>
              <a:off x="416160" y="8366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4211640" y="836640"/>
            <a:ext cx="4319280" cy="3174480"/>
            <a:chOff x="4211640" y="836640"/>
            <a:chExt cx="4319280" cy="3174480"/>
          </a:xfrm>
        </p:grpSpPr>
        <p:graphicFrame>
          <p:nvGraphicFramePr>
            <p:cNvPr id="66" name=""/>
            <p:cNvGraphicFramePr/>
            <p:nvPr/>
          </p:nvGraphicFramePr>
          <p:xfrm>
            <a:off x="4211640" y="1166760"/>
            <a:ext cx="4319280" cy="284436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67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211640" y="1166760"/>
                      <a:ext cx="4319280" cy="2844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8" name=""/>
            <p:cNvSpPr/>
            <p:nvPr/>
          </p:nvSpPr>
          <p:spPr>
            <a:xfrm>
              <a:off x="4284720" y="8366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04T18:38:33Z</dcterms:created>
  <dc:creator>F. Rückert</dc:creator>
  <dc:description/>
  <dc:language>en-US</dc:language>
  <cp:lastModifiedBy>F. Rückert</cp:lastModifiedBy>
  <dcterms:modified xsi:type="dcterms:W3CDTF">2010-04-06T11:30:25Z</dcterms:modified>
  <cp:revision>17</cp:revision>
  <dc:subject/>
  <dc:title>Folie 1</dc:title>
</cp:coreProperties>
</file>